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docx" ContentType="application/vnd.openxmlformats-officedocument.wordprocessingml.document"/>
  <Override PartName="/ppt/embeddings/oleObject2.docx" ContentType="application/vnd.openxmlformats-officedocument.wordprocessingml.document"/>
  <Override PartName="/ppt/media/image1.pct" ContentType="image/x-pict"/>
  <Override PartName="/ppt/media/image2.pct" ContentType="image/x-pict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36AA4B-166A-4F6D-85D8-F0709D83874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582912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967000"/>
            <a:ext cx="582912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2FD24B-459B-4117-8997-B752856C18A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96700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96700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530897-CDDD-4AD3-A58B-7131E0E5592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86236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86236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96700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96700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96700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6E7F9A-6503-4794-8702-C4745619758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862360"/>
            <a:ext cx="5829120" cy="5943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1F193E-4B90-40AD-A7F2-C28AAB7DED5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582912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59949E-2CED-4E7A-B1B3-3D40C2437F7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B51203-6ECB-4DD5-B9E6-6E1CBF5563D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0C27A7-2FFE-4DF5-81FE-6923504C103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80560"/>
            <a:ext cx="582912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822F36-634D-435F-8503-F5A2C1162F7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96700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E4AB5E-08E9-45A2-8DA4-64B2F7360C6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96700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E89261-36EB-479E-86EC-E9C661EDE83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967000"/>
            <a:ext cx="582912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0E2BFA-F683-41D9-8E6C-259700AF871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862360"/>
            <a:ext cx="582912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9024480"/>
            <a:ext cx="1428840" cy="66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4480"/>
            <a:ext cx="2171520" cy="66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9024480"/>
            <a:ext cx="1428480" cy="66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021A0BB-56EB-482D-B53D-456B987F7BC8}" type="slidenum">
              <a:rPr b="0" lang="ja-JP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docx"/><Relationship Id="rId2" Type="http://schemas.openxmlformats.org/officeDocument/2006/relationships/image" Target="../media/image1.pct"/><Relationship Id="rId3" Type="http://schemas.openxmlformats.org/officeDocument/2006/relationships/package" Target="../embeddings/oleObject2.docx"/><Relationship Id="rId4" Type="http://schemas.openxmlformats.org/officeDocument/2006/relationships/image" Target="../media/image2.pct"/><Relationship Id="rId5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26"/>
          <p:cNvGrpSpPr/>
          <p:nvPr/>
        </p:nvGrpSpPr>
        <p:grpSpPr>
          <a:xfrm>
            <a:off x="358920" y="1017720"/>
            <a:ext cx="6094080" cy="8235720"/>
            <a:chOff x="358920" y="1017720"/>
            <a:chExt cx="6094080" cy="8235720"/>
          </a:xfrm>
        </p:grpSpPr>
        <p:sp>
          <p:nvSpPr>
            <p:cNvPr id="42" name="Text Box 3"/>
            <p:cNvSpPr/>
            <p:nvPr/>
          </p:nvSpPr>
          <p:spPr>
            <a:xfrm>
              <a:off x="592200" y="1412640"/>
              <a:ext cx="654120" cy="3852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2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ヒラギノ角ゴ Pro W3"/>
                </a:rPr>
                <a:t>No. 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2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ヒラギノ角ゴ Pro W3"/>
                </a:rPr>
                <a:t>No. 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2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ヒラギノ角ゴ Pro W3"/>
                </a:rPr>
                <a:t>No. 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2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ヒラギノ角ゴ Pro W3"/>
                </a:rPr>
                <a:t>No. 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2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ヒラギノ角ゴ Pro W3"/>
                </a:rPr>
                <a:t>No. 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2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ヒラギノ角ゴ Pro W3"/>
                </a:rPr>
                <a:t>No. 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2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ヒラギノ角ゴ Pro W3"/>
                </a:rPr>
                <a:t>No. 7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2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ヒラギノ角ゴ Pro W3"/>
                </a:rPr>
                <a:t>No. 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2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ヒラギノ角ゴ Pro W3"/>
                </a:rPr>
                <a:t>No. 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2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ヒラギノ角ゴ Pro W3"/>
                </a:rPr>
                <a:t>No. 1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aphicFrame>
          <p:nvGraphicFramePr>
            <p:cNvPr id="43" name=""/>
            <p:cNvGraphicFramePr/>
            <p:nvPr/>
          </p:nvGraphicFramePr>
          <p:xfrm>
            <a:off x="1281240" y="1493640"/>
            <a:ext cx="3992400" cy="3760560"/>
          </p:xfrm>
          <a:graphic>
            <a:graphicData uri="http://schemas.openxmlformats.org/presentationml/2006/ole">
              <p:oleObj progId="Word.Document.12" r:id="rId1" spid="">
                <p:embed/>
                <p:pic>
                  <p:nvPicPr>
                    <p:cNvPr id="44" name="" descr=""/>
                    <p:cNvPicPr/>
                    <p:nvPr/>
                  </p:nvPicPr>
                  <p:blipFill>
                    <a:blip r:embed="rId2"/>
                    <a:stretch/>
                  </p:blipFill>
                  <p:spPr>
                    <a:xfrm>
                      <a:off x="1281240" y="1493640"/>
                      <a:ext cx="3992400" cy="376056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45" name=""/>
            <p:cNvGraphicFramePr/>
            <p:nvPr/>
          </p:nvGraphicFramePr>
          <p:xfrm>
            <a:off x="1281240" y="5418000"/>
            <a:ext cx="3992400" cy="3760200"/>
          </p:xfrm>
          <a:graphic>
            <a:graphicData uri="http://schemas.openxmlformats.org/presentationml/2006/ole">
              <p:oleObj progId="Word.Document.12" r:id="rId3" spid="">
                <p:embed/>
                <p:pic>
                  <p:nvPicPr>
                    <p:cNvPr id="46" name="" descr=""/>
                    <p:cNvPicPr/>
                    <p:nvPr/>
                  </p:nvPicPr>
                  <p:blipFill>
                    <a:blip r:embed="rId4"/>
                    <a:stretch/>
                  </p:blipFill>
                  <p:spPr>
                    <a:xfrm>
                      <a:off x="1281240" y="5418000"/>
                      <a:ext cx="3992400" cy="376020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47" name="Text Box 9"/>
            <p:cNvSpPr/>
            <p:nvPr/>
          </p:nvSpPr>
          <p:spPr>
            <a:xfrm>
              <a:off x="592200" y="5337000"/>
              <a:ext cx="654120" cy="3852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2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ヒラギノ角ゴ Pro W3"/>
                </a:rPr>
                <a:t>No. 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2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ヒラギノ角ゴ Pro W3"/>
                </a:rPr>
                <a:t>No. 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2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ヒラギノ角ゴ Pro W3"/>
                </a:rPr>
                <a:t>No. 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2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ヒラギノ角ゴ Pro W3"/>
                </a:rPr>
                <a:t>No. 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2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ヒラギノ角ゴ Pro W3"/>
                </a:rPr>
                <a:t>No. 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2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ヒラギノ角ゴ Pro W3"/>
                </a:rPr>
                <a:t>No. 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2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ヒラギノ角ゴ Pro W3"/>
                </a:rPr>
                <a:t>No. 7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2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ヒラギノ角ゴ Pro W3"/>
                </a:rPr>
                <a:t>No. 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2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ヒラギノ角ゴ Pro W3"/>
                </a:rPr>
                <a:t>No. 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2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ヒラギノ角ゴ Pro W3"/>
                </a:rPr>
                <a:t>No. 1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Text Box 13"/>
            <p:cNvSpPr/>
            <p:nvPr/>
          </p:nvSpPr>
          <p:spPr>
            <a:xfrm>
              <a:off x="5799240" y="1412640"/>
              <a:ext cx="653760" cy="3852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2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ヒラギノ角ゴ Pro W3"/>
                </a:rPr>
                <a:t>15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2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ヒラギノ角ゴ Pro W3"/>
                </a:rPr>
                <a:t>16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2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ヒラギノ角ゴ Pro W3"/>
                </a:rPr>
                <a:t>12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2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ヒラギノ角ゴ Pro W3"/>
                </a:rPr>
                <a:t>21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2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ヒラギノ角ゴ Pro W3"/>
                </a:rPr>
                <a:t>24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2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ヒラギノ角ゴ Pro W3"/>
                </a:rPr>
                <a:t>20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2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ヒラギノ角ゴ Pro W3"/>
                </a:rPr>
                <a:t>11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2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ヒラギノ角ゴ Pro W3"/>
                </a:rPr>
                <a:t>19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2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ヒラギノ角ゴ Pro W3"/>
                </a:rPr>
                <a:t>16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2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ヒラギノ角ゴ Pro W3"/>
                </a:rPr>
                <a:t>13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Text Box 14"/>
            <p:cNvSpPr/>
            <p:nvPr/>
          </p:nvSpPr>
          <p:spPr>
            <a:xfrm>
              <a:off x="5799240" y="5337000"/>
              <a:ext cx="653760" cy="3852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2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ヒラギノ角ゴ Pro W3"/>
                </a:rPr>
                <a:t>15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2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ヒラギノ角ゴ Pro W3"/>
                </a:rPr>
                <a:t>16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2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ヒラギノ角ゴ Pro W3"/>
                </a:rPr>
                <a:t>12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2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ヒラギノ角ゴ Pro W3"/>
                </a:rPr>
                <a:t>22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2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ヒラギノ角ゴ Pro W3"/>
                </a:rPr>
                <a:t>24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2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ヒラギノ角ゴ Pro W3"/>
                </a:rPr>
                <a:t>20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2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ヒラギノ角ゴ Pro W3"/>
                </a:rPr>
                <a:t>11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2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ヒラギノ角ゴ Pro W3"/>
                </a:rPr>
                <a:t>19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2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ヒラギノ角ゴ Pro W3"/>
                </a:rPr>
                <a:t>16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2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ヒラギノ角ゴ Pro W3"/>
                </a:rPr>
                <a:t>147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Text Box 15"/>
            <p:cNvSpPr/>
            <p:nvPr/>
          </p:nvSpPr>
          <p:spPr>
            <a:xfrm>
              <a:off x="4859280" y="1412640"/>
              <a:ext cx="654120" cy="3852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2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ヒラギノ角ゴ Pro W3"/>
                </a:rPr>
                <a:t>5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2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ヒラギノ角ゴ Pro W3"/>
                </a:rPr>
                <a:t>5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2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ヒラギノ角ゴ Pro W3"/>
                </a:rPr>
                <a:t>5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2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ヒラギノ角ゴ Pro W3"/>
                </a:rPr>
                <a:t>5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2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ヒラギノ角ゴ Pro W3"/>
                </a:rPr>
                <a:t>5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2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ヒラギノ角ゴ Pro W3"/>
                </a:rPr>
                <a:t>5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2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ヒラギノ角ゴ Pro W3"/>
                </a:rPr>
                <a:t>5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2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ヒラギノ角ゴ Pro W3"/>
                </a:rPr>
                <a:t>5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2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ヒラギノ角ゴ Pro W3"/>
                </a:rPr>
                <a:t>5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2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ヒラギノ角ゴ Pro W3"/>
                </a:rPr>
                <a:t>5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Text Box 16"/>
            <p:cNvSpPr/>
            <p:nvPr/>
          </p:nvSpPr>
          <p:spPr>
            <a:xfrm>
              <a:off x="4859280" y="5337000"/>
              <a:ext cx="654120" cy="3852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2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ヒラギノ角ゴ Pro W3"/>
                </a:rPr>
                <a:t>5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2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ヒラギノ角ゴ Pro W3"/>
                </a:rPr>
                <a:t>5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2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ヒラギノ角ゴ Pro W3"/>
                </a:rPr>
                <a:t>5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2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ヒラギノ角ゴ Pro W3"/>
                </a:rPr>
                <a:t>5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2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ヒラギノ角ゴ Pro W3"/>
                </a:rPr>
                <a:t>5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2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ヒラギノ角ゴ Pro W3"/>
                </a:rPr>
                <a:t>5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2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ヒラギノ角ゴ Pro W3"/>
                </a:rPr>
                <a:t>5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2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ヒラギノ角ゴ Pro W3"/>
                </a:rPr>
                <a:t>5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2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ヒラギノ角ゴ Pro W3"/>
                </a:rPr>
                <a:t>5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2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ヒラギノ角ゴ Pro W3"/>
                </a:rPr>
                <a:t>5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Line 17"/>
            <p:cNvSpPr/>
            <p:nvPr/>
          </p:nvSpPr>
          <p:spPr>
            <a:xfrm>
              <a:off x="511200" y="9253440"/>
              <a:ext cx="58291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Line 18"/>
            <p:cNvSpPr/>
            <p:nvPr/>
          </p:nvSpPr>
          <p:spPr>
            <a:xfrm>
              <a:off x="511200" y="5329080"/>
              <a:ext cx="5829120" cy="0"/>
            </a:xfrm>
            <a:prstGeom prst="line">
              <a:avLst/>
            </a:prstGeom>
            <a:ln w="9360">
              <a:solidFill>
                <a:srgbClr val="00000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Line 19"/>
            <p:cNvSpPr/>
            <p:nvPr/>
          </p:nvSpPr>
          <p:spPr>
            <a:xfrm>
              <a:off x="511200" y="1417320"/>
              <a:ext cx="58291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Line 20"/>
            <p:cNvSpPr/>
            <p:nvPr/>
          </p:nvSpPr>
          <p:spPr>
            <a:xfrm>
              <a:off x="511200" y="1023840"/>
              <a:ext cx="58291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Text Box 21"/>
            <p:cNvSpPr/>
            <p:nvPr/>
          </p:nvSpPr>
          <p:spPr>
            <a:xfrm>
              <a:off x="475200" y="1096920"/>
              <a:ext cx="2186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ヒラギノ角ゴ Pro W3"/>
                </a:rPr>
                <a:t>Region No.                       Sequenc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Rectangle 22"/>
            <p:cNvSpPr/>
            <p:nvPr/>
          </p:nvSpPr>
          <p:spPr>
            <a:xfrm>
              <a:off x="4437720" y="1017720"/>
              <a:ext cx="115884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ヒラギノ角ゴ Pro W3"/>
                </a:rPr>
                <a:t>Annealing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ヒラギノ角ゴ Pro W3"/>
                </a:rPr>
                <a:t>temperature (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°C)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ヒラギノ角ゴ Pro W3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Rectangle 23"/>
            <p:cNvSpPr/>
            <p:nvPr/>
          </p:nvSpPr>
          <p:spPr>
            <a:xfrm>
              <a:off x="5674320" y="1017720"/>
              <a:ext cx="66672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ヒラギノ角ゴ Pro W3"/>
                </a:rPr>
                <a:t>Product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ヒラギノ角ゴ Pro W3"/>
                </a:rPr>
                <a:t>size (bp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Text Box 24"/>
            <p:cNvSpPr/>
            <p:nvPr/>
          </p:nvSpPr>
          <p:spPr>
            <a:xfrm rot="16200000">
              <a:off x="114480" y="3304080"/>
              <a:ext cx="798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Arial"/>
                  <a:ea typeface="ヒラギノ角ゴ Pro W3"/>
                </a:rPr>
                <a:t>Methylated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Text Box 25"/>
            <p:cNvSpPr/>
            <p:nvPr/>
          </p:nvSpPr>
          <p:spPr>
            <a:xfrm rot="16200000">
              <a:off x="2160" y="7219800"/>
              <a:ext cx="9594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Arial"/>
                  <a:ea typeface="ヒラギノ角ゴ Pro W3"/>
                </a:rPr>
                <a:t>Unmethylated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1" name="Text Box 27"/>
          <p:cNvSpPr/>
          <p:nvPr/>
        </p:nvSpPr>
        <p:spPr>
          <a:xfrm>
            <a:off x="457200" y="609480"/>
            <a:ext cx="5975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Arial"/>
                <a:ea typeface="ヒラギノ角ゴ Pro W3"/>
              </a:rPr>
              <a:t>Table S1. List of primer sets of methylation specific PC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3-23T08:51:22Z</dcterms:created>
  <dc:creator>工藤 保誠</dc:creator>
  <dc:description/>
  <dc:language>en-US</dc:language>
  <cp:lastModifiedBy>工藤 保誠</cp:lastModifiedBy>
  <dcterms:modified xsi:type="dcterms:W3CDTF">2009-05-01T09:46:37Z</dcterms:modified>
  <cp:revision>6</cp:revision>
  <dc:subject/>
  <dc:title>PowerPoint プレゼンテーション</dc:title>
</cp:coreProperties>
</file>